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2D3418-7984-4D96-B398-CD192C20D63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6C55DC-95BE-4904-8FC4-1A6815FA7C3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5AD875-67CD-4957-896F-17D572FF3A6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B3A1AA-E60E-450D-9775-8059CD7FE33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DF774F-5138-43C8-BA54-B5D4141D00C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AB4B69-59E8-4A2F-A2AC-FC22AFDC13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E68AD4-AA93-4C7D-AF32-6ACAEE0C0F0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BAF5C6-221B-4F71-B7FD-7060BE70BA6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628818-FA56-4ADC-B78B-FA90D838F9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D062E7-1128-4183-B6CA-023A6DD3A6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1D033D-C152-4688-93AE-E739187B2B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2B46C7-9E25-4E50-AE9D-88380E0579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FFA3253-3B8F-4F5D-B9FA-172907C60C0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578880" y="327600"/>
            <a:ext cx="4034520" cy="6359400"/>
            <a:chOff x="578880" y="327600"/>
            <a:chExt cx="4034520" cy="6359400"/>
          </a:xfrm>
        </p:grpSpPr>
        <p:grpSp>
          <p:nvGrpSpPr>
            <p:cNvPr id="42" name=""/>
            <p:cNvGrpSpPr/>
            <p:nvPr/>
          </p:nvGrpSpPr>
          <p:grpSpPr>
            <a:xfrm>
              <a:off x="578880" y="358920"/>
              <a:ext cx="2739240" cy="5883480"/>
              <a:chOff x="578880" y="358920"/>
              <a:chExt cx="2739240" cy="5883480"/>
            </a:xfrm>
          </p:grpSpPr>
          <p:sp>
            <p:nvSpPr>
              <p:cNvPr id="43" name=""/>
              <p:cNvSpPr/>
              <p:nvPr/>
            </p:nvSpPr>
            <p:spPr>
              <a:xfrm>
                <a:off x="578880" y="970920"/>
                <a:ext cx="1760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" name=""/>
              <p:cNvSpPr/>
              <p:nvPr/>
            </p:nvSpPr>
            <p:spPr>
              <a:xfrm flipV="1">
                <a:off x="754920" y="587160"/>
                <a:ext cx="0" cy="3837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754920" y="587160"/>
                <a:ext cx="1764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 flipV="1">
                <a:off x="931320" y="358920"/>
                <a:ext cx="0" cy="228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931320" y="358920"/>
                <a:ext cx="975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931320" y="587160"/>
                <a:ext cx="0" cy="51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931320" y="638640"/>
                <a:ext cx="82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 flipV="1">
                <a:off x="1014480" y="534960"/>
                <a:ext cx="0" cy="1036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1014480" y="534960"/>
                <a:ext cx="1656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 flipV="1">
                <a:off x="1180440" y="482760"/>
                <a:ext cx="0" cy="51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1180440" y="483120"/>
                <a:ext cx="7988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1180440" y="534960"/>
                <a:ext cx="0" cy="62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480" bIns="15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1180440" y="597240"/>
                <a:ext cx="8510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1014480" y="638640"/>
                <a:ext cx="0" cy="1450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1014480" y="784080"/>
                <a:ext cx="3319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 flipV="1">
                <a:off x="1346760" y="721800"/>
                <a:ext cx="0" cy="61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1346760" y="721800"/>
                <a:ext cx="7779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1346760" y="784080"/>
                <a:ext cx="0" cy="51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040" bIns="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1346760" y="835920"/>
                <a:ext cx="5706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754920" y="970920"/>
                <a:ext cx="0" cy="23140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754920" y="3285000"/>
                <a:ext cx="82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 flipV="1">
                <a:off x="838080" y="1230120"/>
                <a:ext cx="0" cy="2054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838080" y="1230120"/>
                <a:ext cx="4564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 flipV="1">
                <a:off x="1294560" y="1043640"/>
                <a:ext cx="0" cy="186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1294560" y="1043640"/>
                <a:ext cx="1555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 flipV="1">
                <a:off x="1450080" y="949680"/>
                <a:ext cx="0" cy="93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440" bIns="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1450080" y="950040"/>
                <a:ext cx="5810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1450080" y="1043640"/>
                <a:ext cx="0" cy="82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640" bIns="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1450080" y="1126440"/>
                <a:ext cx="622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 flipV="1">
                <a:off x="2072880" y="1074240"/>
                <a:ext cx="0" cy="51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2072880" y="1074600"/>
                <a:ext cx="410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2072880" y="1126440"/>
                <a:ext cx="0" cy="62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480" bIns="15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2072880" y="1188720"/>
                <a:ext cx="514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1294560" y="1230120"/>
                <a:ext cx="0" cy="2595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1294560" y="1490040"/>
                <a:ext cx="4255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 flipV="1">
                <a:off x="1720080" y="1365120"/>
                <a:ext cx="0" cy="1245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1720080" y="1365120"/>
                <a:ext cx="2487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 flipV="1">
                <a:off x="1969200" y="1302480"/>
                <a:ext cx="0" cy="62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480" bIns="15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1969200" y="1302840"/>
                <a:ext cx="1864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1969200" y="1365120"/>
                <a:ext cx="0" cy="62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480" bIns="15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1969200" y="1427400"/>
                <a:ext cx="1972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1720080" y="1490040"/>
                <a:ext cx="0" cy="1033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1720080" y="1593360"/>
                <a:ext cx="1555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 flipV="1">
                <a:off x="1875600" y="1541160"/>
                <a:ext cx="0" cy="51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1875600" y="1541520"/>
                <a:ext cx="1242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1875600" y="1593360"/>
                <a:ext cx="0" cy="62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480" bIns="15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1875600" y="1656000"/>
                <a:ext cx="2487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838080" y="3285000"/>
                <a:ext cx="0" cy="5083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838080" y="3793320"/>
                <a:ext cx="514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 flipV="1">
                <a:off x="889560" y="3181320"/>
                <a:ext cx="0" cy="6120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889560" y="3181320"/>
                <a:ext cx="414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 flipV="1">
                <a:off x="931320" y="2838600"/>
                <a:ext cx="0" cy="3423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931320" y="2838960"/>
                <a:ext cx="1245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 flipV="1">
                <a:off x="1055880" y="2309400"/>
                <a:ext cx="0" cy="528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1055880" y="2309760"/>
                <a:ext cx="3938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 flipV="1">
                <a:off x="1450080" y="1956600"/>
                <a:ext cx="0" cy="352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1450080" y="1956600"/>
                <a:ext cx="238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 flipV="1">
                <a:off x="1689120" y="1832040"/>
                <a:ext cx="0" cy="1242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1689120" y="1832400"/>
                <a:ext cx="10479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 flipV="1">
                <a:off x="2737080" y="1780200"/>
                <a:ext cx="0" cy="51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040" bIns="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2737080" y="178020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2737080" y="1832400"/>
                <a:ext cx="0" cy="61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2737080" y="189432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1689120" y="1956600"/>
                <a:ext cx="0" cy="51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1689120" y="200844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1450080" y="2309760"/>
                <a:ext cx="0" cy="3837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1450080" y="2693520"/>
                <a:ext cx="3319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 flipV="1">
                <a:off x="1782360" y="2496240"/>
                <a:ext cx="0" cy="197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1782360" y="2496240"/>
                <a:ext cx="114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 flipV="1">
                <a:off x="1896480" y="2371680"/>
                <a:ext cx="0" cy="1245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1896480" y="2371680"/>
                <a:ext cx="1242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 flipV="1">
                <a:off x="2020680" y="2278080"/>
                <a:ext cx="0" cy="93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440" bIns="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2020680" y="2278440"/>
                <a:ext cx="1346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 flipV="1">
                <a:off x="2155680" y="2184480"/>
                <a:ext cx="0" cy="93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440" bIns="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2155680" y="2184840"/>
                <a:ext cx="205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 flipV="1">
                <a:off x="2176560" y="2132640"/>
                <a:ext cx="0" cy="51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2176560" y="2133000"/>
                <a:ext cx="2487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2176560" y="2184840"/>
                <a:ext cx="0" cy="62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480" bIns="15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2176560" y="2247480"/>
                <a:ext cx="2487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>
                <a:off x="2155680" y="2278440"/>
                <a:ext cx="0" cy="82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00" bIns="36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2155680" y="2361600"/>
                <a:ext cx="103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2020680" y="2371680"/>
                <a:ext cx="0" cy="114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2020680" y="2486160"/>
                <a:ext cx="4046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1896480" y="2496240"/>
                <a:ext cx="0" cy="1656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1896480" y="2662200"/>
                <a:ext cx="591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 flipV="1">
                <a:off x="2487960" y="2600280"/>
                <a:ext cx="0" cy="61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2487960" y="2600280"/>
                <a:ext cx="6120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2487960" y="2662200"/>
                <a:ext cx="0" cy="51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040" bIns="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2487960" y="271440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1782360" y="2693520"/>
                <a:ext cx="0" cy="1965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1782360" y="2890440"/>
                <a:ext cx="1656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 flipV="1">
                <a:off x="1948320" y="2838600"/>
                <a:ext cx="0" cy="51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1948320" y="2838960"/>
                <a:ext cx="3319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1948320" y="2890440"/>
                <a:ext cx="0" cy="62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480" bIns="15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1948320" y="2953080"/>
                <a:ext cx="3423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1055880" y="2838960"/>
                <a:ext cx="0" cy="311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1055880" y="3150360"/>
                <a:ext cx="114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 flipV="1">
                <a:off x="1170000" y="3067200"/>
                <a:ext cx="0" cy="82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00" bIns="36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1170000" y="3067200"/>
                <a:ext cx="9234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1170000" y="3150360"/>
                <a:ext cx="0" cy="93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440" bIns="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1170000" y="3243600"/>
                <a:ext cx="10580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 flipV="1">
                <a:off x="2228400" y="3191400"/>
                <a:ext cx="0" cy="51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2228400" y="3191760"/>
                <a:ext cx="757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2228400" y="3243600"/>
                <a:ext cx="0" cy="62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480" bIns="15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2228400" y="3305880"/>
                <a:ext cx="6642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931320" y="3181320"/>
                <a:ext cx="0" cy="6847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931320" y="3866040"/>
                <a:ext cx="4255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 flipV="1">
                <a:off x="1356840" y="3648240"/>
                <a:ext cx="0" cy="217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1356840" y="3648240"/>
                <a:ext cx="309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 flipV="1">
                <a:off x="1387800" y="3482280"/>
                <a:ext cx="0" cy="1656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1387800" y="3482280"/>
                <a:ext cx="2696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 flipV="1">
                <a:off x="1657800" y="3419640"/>
                <a:ext cx="0" cy="62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480" bIns="15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>
                <a:off x="1657800" y="3420000"/>
                <a:ext cx="3423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>
                <a:off x="1657800" y="3482280"/>
                <a:ext cx="0" cy="61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>
                <a:off x="1657800" y="3544560"/>
                <a:ext cx="4255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1387800" y="3648240"/>
                <a:ext cx="0" cy="186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1387800" y="3835080"/>
                <a:ext cx="3319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 flipV="1">
                <a:off x="1720080" y="3720600"/>
                <a:ext cx="0" cy="114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>
                <a:off x="1720080" y="3720960"/>
                <a:ext cx="3837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 flipV="1">
                <a:off x="2103840" y="3658320"/>
                <a:ext cx="0" cy="62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480" bIns="15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2103840" y="3658680"/>
                <a:ext cx="103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2103840" y="3720960"/>
                <a:ext cx="0" cy="51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2103840" y="3772800"/>
                <a:ext cx="1764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1720080" y="3835080"/>
                <a:ext cx="0" cy="1245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1720080" y="3959640"/>
                <a:ext cx="3319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 flipV="1">
                <a:off x="2052360" y="3897000"/>
                <a:ext cx="0" cy="62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480" bIns="15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>
                <a:off x="2052360" y="3897360"/>
                <a:ext cx="2592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>
                <a:off x="2052360" y="3959640"/>
                <a:ext cx="0" cy="51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>
                <a:off x="2052360" y="4011480"/>
                <a:ext cx="1033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"/>
              <p:cNvSpPr/>
              <p:nvPr/>
            </p:nvSpPr>
            <p:spPr>
              <a:xfrm>
                <a:off x="1356840" y="3866040"/>
                <a:ext cx="0" cy="321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>
                <a:off x="1356840" y="4187880"/>
                <a:ext cx="4046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 flipV="1">
                <a:off x="1761480" y="4125240"/>
                <a:ext cx="0" cy="62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480" bIns="15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"/>
              <p:cNvSpPr/>
              <p:nvPr/>
            </p:nvSpPr>
            <p:spPr>
              <a:xfrm>
                <a:off x="1761480" y="4125600"/>
                <a:ext cx="3837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"/>
              <p:cNvSpPr/>
              <p:nvPr/>
            </p:nvSpPr>
            <p:spPr>
              <a:xfrm>
                <a:off x="1761480" y="4187880"/>
                <a:ext cx="0" cy="61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>
                <a:off x="1761480" y="4250160"/>
                <a:ext cx="2797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>
                <a:off x="889560" y="3793320"/>
                <a:ext cx="0" cy="1380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>
                <a:off x="889560" y="5173560"/>
                <a:ext cx="2696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 flipV="1">
                <a:off x="1159560" y="4789800"/>
                <a:ext cx="0" cy="3837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"/>
              <p:cNvSpPr/>
              <p:nvPr/>
            </p:nvSpPr>
            <p:spPr>
              <a:xfrm>
                <a:off x="1159560" y="4789800"/>
                <a:ext cx="205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 flipV="1">
                <a:off x="1180440" y="4426560"/>
                <a:ext cx="0" cy="362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>
                <a:off x="1180440" y="4426560"/>
                <a:ext cx="5601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 flipV="1">
                <a:off x="1740960" y="4363920"/>
                <a:ext cx="0" cy="62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480" bIns="15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>
                <a:off x="1740960" y="4364280"/>
                <a:ext cx="7365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>
                <a:off x="1740960" y="4426560"/>
                <a:ext cx="0" cy="51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040" bIns="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>
                <a:off x="1740960" y="4478760"/>
                <a:ext cx="5497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>
                <a:off x="1180440" y="4789800"/>
                <a:ext cx="0" cy="3837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>
                <a:off x="1180440" y="5173560"/>
                <a:ext cx="632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 flipV="1">
                <a:off x="1813320" y="4903560"/>
                <a:ext cx="0" cy="269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>
                <a:off x="1813320" y="4903920"/>
                <a:ext cx="103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 flipV="1">
                <a:off x="1917360" y="4748040"/>
                <a:ext cx="0" cy="1555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>
                <a:off x="1917360" y="4748040"/>
                <a:ext cx="217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 flipV="1">
                <a:off x="2134800" y="4654440"/>
                <a:ext cx="0" cy="93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440" bIns="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>
                <a:off x="2134800" y="4654800"/>
                <a:ext cx="5187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 flipV="1">
                <a:off x="2653920" y="4602600"/>
                <a:ext cx="0" cy="51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>
                <a:off x="2653920" y="4602960"/>
                <a:ext cx="2595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>
                <a:off x="2653920" y="4654800"/>
                <a:ext cx="0" cy="62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480" bIns="15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>
                <a:off x="2653920" y="4717080"/>
                <a:ext cx="217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"/>
              <p:cNvSpPr/>
              <p:nvPr/>
            </p:nvSpPr>
            <p:spPr>
              <a:xfrm>
                <a:off x="2134800" y="4748040"/>
                <a:ext cx="0" cy="82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00" bIns="36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"/>
              <p:cNvSpPr/>
              <p:nvPr/>
            </p:nvSpPr>
            <p:spPr>
              <a:xfrm>
                <a:off x="2134800" y="4831200"/>
                <a:ext cx="5709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>
                <a:off x="1917360" y="4903920"/>
                <a:ext cx="0" cy="197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>
                <a:off x="1917360" y="5101200"/>
                <a:ext cx="445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 flipV="1">
                <a:off x="2363400" y="5018040"/>
                <a:ext cx="0" cy="82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00" bIns="36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>
                <a:off x="2363400" y="5018040"/>
                <a:ext cx="10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 flipV="1">
                <a:off x="2373840" y="4956120"/>
                <a:ext cx="0" cy="61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>
                <a:off x="2373840" y="4956120"/>
                <a:ext cx="9442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"/>
              <p:cNvSpPr/>
              <p:nvPr/>
            </p:nvSpPr>
            <p:spPr>
              <a:xfrm>
                <a:off x="2373840" y="5018040"/>
                <a:ext cx="0" cy="51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040" bIns="5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>
                <a:off x="2373840" y="5070240"/>
                <a:ext cx="4046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"/>
              <p:cNvSpPr/>
              <p:nvPr/>
            </p:nvSpPr>
            <p:spPr>
              <a:xfrm>
                <a:off x="2363400" y="5101200"/>
                <a:ext cx="0" cy="82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00" bIns="36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>
                <a:off x="2363400" y="5184360"/>
                <a:ext cx="2696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>
                <a:off x="1813320" y="5173560"/>
                <a:ext cx="0" cy="269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>
                <a:off x="1813320" y="5443560"/>
                <a:ext cx="1245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 flipV="1">
                <a:off x="1938240" y="5360400"/>
                <a:ext cx="0" cy="82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00" bIns="36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>
                <a:off x="1938240" y="5360400"/>
                <a:ext cx="1555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 flipV="1">
                <a:off x="2093760" y="5308200"/>
                <a:ext cx="0" cy="51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>
                <a:off x="2093760" y="5308560"/>
                <a:ext cx="4147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"/>
              <p:cNvSpPr/>
              <p:nvPr/>
            </p:nvSpPr>
            <p:spPr>
              <a:xfrm>
                <a:off x="2093760" y="5360400"/>
                <a:ext cx="0" cy="62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480" bIns="15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"/>
              <p:cNvSpPr/>
              <p:nvPr/>
            </p:nvSpPr>
            <p:spPr>
              <a:xfrm>
                <a:off x="2093760" y="5422680"/>
                <a:ext cx="5706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"/>
              <p:cNvSpPr/>
              <p:nvPr/>
            </p:nvSpPr>
            <p:spPr>
              <a:xfrm>
                <a:off x="1938240" y="5443560"/>
                <a:ext cx="0" cy="93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440" bIns="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"/>
              <p:cNvSpPr/>
              <p:nvPr/>
            </p:nvSpPr>
            <p:spPr>
              <a:xfrm>
                <a:off x="1938240" y="5536800"/>
                <a:ext cx="4665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"/>
              <p:cNvSpPr/>
              <p:nvPr/>
            </p:nvSpPr>
            <p:spPr>
              <a:xfrm>
                <a:off x="1159560" y="5173560"/>
                <a:ext cx="0" cy="716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"/>
              <p:cNvSpPr/>
              <p:nvPr/>
            </p:nvSpPr>
            <p:spPr>
              <a:xfrm>
                <a:off x="1159560" y="5889960"/>
                <a:ext cx="373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"/>
              <p:cNvSpPr/>
              <p:nvPr/>
            </p:nvSpPr>
            <p:spPr>
              <a:xfrm flipV="1">
                <a:off x="1533240" y="5713560"/>
                <a:ext cx="0" cy="176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"/>
              <p:cNvSpPr/>
              <p:nvPr/>
            </p:nvSpPr>
            <p:spPr>
              <a:xfrm>
                <a:off x="1533240" y="5713560"/>
                <a:ext cx="2905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"/>
              <p:cNvSpPr/>
              <p:nvPr/>
            </p:nvSpPr>
            <p:spPr>
              <a:xfrm flipV="1">
                <a:off x="1824120" y="5661360"/>
                <a:ext cx="0" cy="51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"/>
              <p:cNvSpPr/>
              <p:nvPr/>
            </p:nvSpPr>
            <p:spPr>
              <a:xfrm>
                <a:off x="1824120" y="5661720"/>
                <a:ext cx="715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"/>
              <p:cNvSpPr/>
              <p:nvPr/>
            </p:nvSpPr>
            <p:spPr>
              <a:xfrm>
                <a:off x="1824120" y="5713560"/>
                <a:ext cx="0" cy="62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480" bIns="15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"/>
              <p:cNvSpPr/>
              <p:nvPr/>
            </p:nvSpPr>
            <p:spPr>
              <a:xfrm>
                <a:off x="1824120" y="5775840"/>
                <a:ext cx="8193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"/>
              <p:cNvSpPr/>
              <p:nvPr/>
            </p:nvSpPr>
            <p:spPr>
              <a:xfrm>
                <a:off x="1533240" y="5889960"/>
                <a:ext cx="0" cy="176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"/>
              <p:cNvSpPr/>
              <p:nvPr/>
            </p:nvSpPr>
            <p:spPr>
              <a:xfrm>
                <a:off x="1533240" y="6066360"/>
                <a:ext cx="3423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"/>
              <p:cNvSpPr/>
              <p:nvPr/>
            </p:nvSpPr>
            <p:spPr>
              <a:xfrm flipV="1">
                <a:off x="1875600" y="5951880"/>
                <a:ext cx="0" cy="114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"/>
              <p:cNvSpPr/>
              <p:nvPr/>
            </p:nvSpPr>
            <p:spPr>
              <a:xfrm>
                <a:off x="1875600" y="5952240"/>
                <a:ext cx="414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"/>
              <p:cNvSpPr/>
              <p:nvPr/>
            </p:nvSpPr>
            <p:spPr>
              <a:xfrm flipV="1">
                <a:off x="1917360" y="5889600"/>
                <a:ext cx="0" cy="62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480" bIns="15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"/>
              <p:cNvSpPr/>
              <p:nvPr/>
            </p:nvSpPr>
            <p:spPr>
              <a:xfrm>
                <a:off x="1917360" y="5889960"/>
                <a:ext cx="445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"/>
              <p:cNvSpPr/>
              <p:nvPr/>
            </p:nvSpPr>
            <p:spPr>
              <a:xfrm>
                <a:off x="1917360" y="5952240"/>
                <a:ext cx="0" cy="61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"/>
              <p:cNvSpPr/>
              <p:nvPr/>
            </p:nvSpPr>
            <p:spPr>
              <a:xfrm>
                <a:off x="1917360" y="6014160"/>
                <a:ext cx="580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"/>
              <p:cNvSpPr/>
              <p:nvPr/>
            </p:nvSpPr>
            <p:spPr>
              <a:xfrm>
                <a:off x="1875600" y="6066360"/>
                <a:ext cx="0" cy="1242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"/>
              <p:cNvSpPr/>
              <p:nvPr/>
            </p:nvSpPr>
            <p:spPr>
              <a:xfrm>
                <a:off x="1875600" y="6190920"/>
                <a:ext cx="414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"/>
              <p:cNvSpPr/>
              <p:nvPr/>
            </p:nvSpPr>
            <p:spPr>
              <a:xfrm flipV="1">
                <a:off x="1917360" y="6127920"/>
                <a:ext cx="0" cy="62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480" bIns="15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"/>
              <p:cNvSpPr/>
              <p:nvPr/>
            </p:nvSpPr>
            <p:spPr>
              <a:xfrm>
                <a:off x="1917360" y="6128280"/>
                <a:ext cx="6220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"/>
              <p:cNvSpPr/>
              <p:nvPr/>
            </p:nvSpPr>
            <p:spPr>
              <a:xfrm>
                <a:off x="1917360" y="6190920"/>
                <a:ext cx="0" cy="51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43" name=""/>
            <p:cNvSpPr/>
            <p:nvPr/>
          </p:nvSpPr>
          <p:spPr>
            <a:xfrm>
              <a:off x="1917360" y="6243120"/>
              <a:ext cx="4255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754920" y="971280"/>
              <a:ext cx="0" cy="54896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754920" y="6461280"/>
              <a:ext cx="24804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 flipV="1">
              <a:off x="3235680" y="6367320"/>
              <a:ext cx="0" cy="932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440" bIns="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3235680" y="6367680"/>
              <a:ext cx="7570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3235680" y="6461280"/>
              <a:ext cx="0" cy="828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3235680" y="6544440"/>
              <a:ext cx="5810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 flipV="1">
              <a:off x="3816720" y="6481440"/>
              <a:ext cx="0" cy="622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480" bIns="15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3816720" y="6481800"/>
              <a:ext cx="2174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3816720" y="6544440"/>
              <a:ext cx="0" cy="61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3816720" y="6606360"/>
              <a:ext cx="1656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1950840" y="327600"/>
              <a:ext cx="823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AT2G33810_SPL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2015640" y="452160"/>
              <a:ext cx="52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1G531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2067480" y="566280"/>
              <a:ext cx="52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3G152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2175840" y="68040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7g321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1959120" y="80496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1g267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2064960" y="919080"/>
              <a:ext cx="46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1G020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2154960" y="103320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4g561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2155320" y="115776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5g246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2196720" y="127224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3g057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2217240" y="138636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2g080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2067480" y="1510560"/>
              <a:ext cx="858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6g44860_SPL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2155320" y="162468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1g3139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2774160" y="1739160"/>
              <a:ext cx="52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5G505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2774160" y="1863720"/>
              <a:ext cx="52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5G506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1730880" y="197784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4g189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2466360" y="209196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8g419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2475360" y="221832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9g3294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>
              <a:off x="2289960" y="233064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4g346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2466360" y="245520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3g412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>
              <a:off x="3141000" y="256932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4g1889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>
              <a:off x="2527200" y="268344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11g303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>
              <a:off x="2319840" y="280800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1g6983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2331720" y="292212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2g591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2129760" y="3036240"/>
              <a:ext cx="52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1G691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3035880" y="316260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1g188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>
              <a:off x="2934720" y="327492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2g112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2036520" y="3389040"/>
              <a:ext cx="52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2G470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>
              <a:off x="2120400" y="3513960"/>
              <a:ext cx="52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3G6003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>
              <a:off x="2244240" y="3628080"/>
              <a:ext cx="52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1G2098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"/>
            <p:cNvSpPr/>
            <p:nvPr/>
          </p:nvSpPr>
          <p:spPr>
            <a:xfrm>
              <a:off x="2316600" y="3743640"/>
              <a:ext cx="52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1G7658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>
              <a:off x="2362320" y="386640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8g402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>
              <a:off x="2196720" y="398088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3g402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"/>
            <p:cNvSpPr/>
            <p:nvPr/>
          </p:nvSpPr>
          <p:spPr>
            <a:xfrm>
              <a:off x="2196360" y="409500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3g617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"/>
            <p:cNvSpPr/>
            <p:nvPr/>
          </p:nvSpPr>
          <p:spPr>
            <a:xfrm>
              <a:off x="2083680" y="421956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1g027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>
              <a:off x="2518200" y="433368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4g4658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2331720" y="444780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5g177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2950920" y="4574160"/>
              <a:ext cx="52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1G273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2909160" y="4688280"/>
              <a:ext cx="52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1G273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2742120" y="4802400"/>
              <a:ext cx="52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5G432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>
              <a:off x="3369240" y="492516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6g453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"/>
            <p:cNvSpPr/>
            <p:nvPr/>
          </p:nvSpPr>
          <p:spPr>
            <a:xfrm>
              <a:off x="2829600" y="503928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2g0778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"/>
            <p:cNvSpPr/>
            <p:nvPr/>
          </p:nvSpPr>
          <p:spPr>
            <a:xfrm>
              <a:off x="2675160" y="515340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3g055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"/>
            <p:cNvSpPr/>
            <p:nvPr/>
          </p:nvSpPr>
          <p:spPr>
            <a:xfrm>
              <a:off x="2559600" y="527796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6g490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"/>
            <p:cNvSpPr/>
            <p:nvPr/>
          </p:nvSpPr>
          <p:spPr>
            <a:xfrm>
              <a:off x="2715480" y="539244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2g0468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"/>
            <p:cNvSpPr/>
            <p:nvPr/>
          </p:nvSpPr>
          <p:spPr>
            <a:xfrm>
              <a:off x="2445840" y="550656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3g035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>
              <a:off x="2576160" y="5632560"/>
              <a:ext cx="52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2G422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"/>
            <p:cNvSpPr/>
            <p:nvPr/>
          </p:nvSpPr>
          <p:spPr>
            <a:xfrm>
              <a:off x="2669760" y="5747040"/>
              <a:ext cx="52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3G579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"/>
            <p:cNvSpPr/>
            <p:nvPr/>
          </p:nvSpPr>
          <p:spPr>
            <a:xfrm>
              <a:off x="2404080" y="585900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8g3989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"/>
            <p:cNvSpPr/>
            <p:nvPr/>
          </p:nvSpPr>
          <p:spPr>
            <a:xfrm>
              <a:off x="2540160" y="598392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3g4003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"/>
            <p:cNvSpPr/>
            <p:nvPr/>
          </p:nvSpPr>
          <p:spPr>
            <a:xfrm>
              <a:off x="2589480" y="609948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9g3143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"/>
            <p:cNvSpPr/>
            <p:nvPr/>
          </p:nvSpPr>
          <p:spPr>
            <a:xfrm>
              <a:off x="2374200" y="621360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4g337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"/>
            <p:cNvSpPr/>
            <p:nvPr/>
          </p:nvSpPr>
          <p:spPr>
            <a:xfrm>
              <a:off x="4029840" y="6336720"/>
              <a:ext cx="52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5G1883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4085280" y="645084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5g338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"/>
            <p:cNvSpPr/>
            <p:nvPr/>
          </p:nvSpPr>
          <p:spPr>
            <a:xfrm>
              <a:off x="4024440" y="656496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2g2558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08" name=""/>
          <p:cNvSpPr/>
          <p:nvPr/>
        </p:nvSpPr>
        <p:spPr>
          <a:xfrm>
            <a:off x="2977200" y="6302520"/>
            <a:ext cx="3268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"/>
          <p:cNvSpPr/>
          <p:nvPr/>
        </p:nvSpPr>
        <p:spPr>
          <a:xfrm>
            <a:off x="1545120" y="402732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"/>
          <p:cNvSpPr/>
          <p:nvPr/>
        </p:nvSpPr>
        <p:spPr>
          <a:xfrm>
            <a:off x="1889640" y="356400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"/>
          <p:cNvSpPr/>
          <p:nvPr/>
        </p:nvSpPr>
        <p:spPr>
          <a:xfrm>
            <a:off x="1834200" y="380700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"/>
          <p:cNvSpPr/>
          <p:nvPr/>
        </p:nvSpPr>
        <p:spPr>
          <a:xfrm>
            <a:off x="2521440" y="167004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>
            <a:off x="1809000" y="966960"/>
            <a:ext cx="3268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"/>
          <p:cNvSpPr/>
          <p:nvPr/>
        </p:nvSpPr>
        <p:spPr>
          <a:xfrm>
            <a:off x="2016720" y="308448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"/>
          <p:cNvSpPr/>
          <p:nvPr/>
        </p:nvSpPr>
        <p:spPr>
          <a:xfrm>
            <a:off x="1504800" y="1335240"/>
            <a:ext cx="3319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>
            <a:off x="2278440" y="250668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"/>
          <p:cNvSpPr/>
          <p:nvPr/>
        </p:nvSpPr>
        <p:spPr>
          <a:xfrm>
            <a:off x="1603800" y="501480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"/>
          <p:cNvSpPr/>
          <p:nvPr/>
        </p:nvSpPr>
        <p:spPr>
          <a:xfrm>
            <a:off x="1524600" y="427212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>
            <a:off x="2442240" y="450072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"/>
          <p:cNvSpPr/>
          <p:nvPr/>
        </p:nvSpPr>
        <p:spPr>
          <a:xfrm>
            <a:off x="2143800" y="494496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"/>
          <p:cNvSpPr/>
          <p:nvPr/>
        </p:nvSpPr>
        <p:spPr>
          <a:xfrm>
            <a:off x="5003640" y="476280"/>
            <a:ext cx="2592720" cy="129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At = Arabidops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Os = Ric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Bd = Brachypodiu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Bootstrap support of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≥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90% show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(1000 dataset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22T14:13:25Z</dcterms:created>
  <dc:creator>Janet Higgins</dc:creator>
  <dc:description/>
  <dc:language>en-US</dc:language>
  <cp:lastModifiedBy>Janet Higgins</cp:lastModifiedBy>
  <dcterms:modified xsi:type="dcterms:W3CDTF">2010-01-06T12:11:38Z</dcterms:modified>
  <cp:revision>6</cp:revision>
  <dc:subject/>
  <dc:title>Slide 1</dc:title>
</cp:coreProperties>
</file>